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37"/>
    <p:restoredTop sz="96250"/>
  </p:normalViewPr>
  <p:slideViewPr>
    <p:cSldViewPr snapToGrid="0" snapToObjects="1">
      <p:cViewPr varScale="1">
        <p:scale>
          <a:sx n="96" d="100"/>
          <a:sy n="96" d="100"/>
        </p:scale>
        <p:origin x="200" y="8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salvatoreesposito/GoogleDrive/arbor/arbor1.0/writing/Revision_1/het_new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Foglio2!$B$4</c:f>
              <c:strCache>
                <c:ptCount val="1"/>
                <c:pt idx="0">
                  <c:v>% homozygous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Foglio2!$A$5:$A$25</c:f>
              <c:strCache>
                <c:ptCount val="21"/>
                <c:pt idx="0">
                  <c:v>1A</c:v>
                </c:pt>
                <c:pt idx="1">
                  <c:v>2A</c:v>
                </c:pt>
                <c:pt idx="2">
                  <c:v>3A</c:v>
                </c:pt>
                <c:pt idx="3">
                  <c:v>4A</c:v>
                </c:pt>
                <c:pt idx="4">
                  <c:v>5A</c:v>
                </c:pt>
                <c:pt idx="5">
                  <c:v>6A</c:v>
                </c:pt>
                <c:pt idx="6">
                  <c:v>7A</c:v>
                </c:pt>
                <c:pt idx="7">
                  <c:v>1B</c:v>
                </c:pt>
                <c:pt idx="8">
                  <c:v>2B</c:v>
                </c:pt>
                <c:pt idx="9">
                  <c:v>3B</c:v>
                </c:pt>
                <c:pt idx="10">
                  <c:v>4B</c:v>
                </c:pt>
                <c:pt idx="11">
                  <c:v>5B</c:v>
                </c:pt>
                <c:pt idx="12">
                  <c:v>6B</c:v>
                </c:pt>
                <c:pt idx="13">
                  <c:v>7B</c:v>
                </c:pt>
                <c:pt idx="14">
                  <c:v>1D</c:v>
                </c:pt>
                <c:pt idx="15">
                  <c:v>2D</c:v>
                </c:pt>
                <c:pt idx="16">
                  <c:v>3D</c:v>
                </c:pt>
                <c:pt idx="17">
                  <c:v>4D</c:v>
                </c:pt>
                <c:pt idx="18">
                  <c:v>5D</c:v>
                </c:pt>
                <c:pt idx="19">
                  <c:v>6D</c:v>
                </c:pt>
                <c:pt idx="20">
                  <c:v>7D</c:v>
                </c:pt>
              </c:strCache>
            </c:strRef>
          </c:cat>
          <c:val>
            <c:numRef>
              <c:f>Foglio2!$B$5:$B$25</c:f>
              <c:numCache>
                <c:formatCode>0.00</c:formatCode>
                <c:ptCount val="21"/>
                <c:pt idx="0">
                  <c:v>93.234049999999996</c:v>
                </c:pt>
                <c:pt idx="1">
                  <c:v>92.695740000000001</c:v>
                </c:pt>
                <c:pt idx="2">
                  <c:v>94.674869999999999</c:v>
                </c:pt>
                <c:pt idx="3">
                  <c:v>94.600210000000004</c:v>
                </c:pt>
                <c:pt idx="4">
                  <c:v>95.170199999999994</c:v>
                </c:pt>
                <c:pt idx="5">
                  <c:v>94.341639999999998</c:v>
                </c:pt>
                <c:pt idx="6">
                  <c:v>94.667640000000006</c:v>
                </c:pt>
                <c:pt idx="7">
                  <c:v>94.557860000000005</c:v>
                </c:pt>
                <c:pt idx="8">
                  <c:v>93.299549999999996</c:v>
                </c:pt>
                <c:pt idx="9">
                  <c:v>94.759529999999998</c:v>
                </c:pt>
                <c:pt idx="10">
                  <c:v>95.415490000000005</c:v>
                </c:pt>
                <c:pt idx="11">
                  <c:v>94.999830000000003</c:v>
                </c:pt>
                <c:pt idx="12">
                  <c:v>93.852829999999997</c:v>
                </c:pt>
                <c:pt idx="13">
                  <c:v>95.023359999999997</c:v>
                </c:pt>
                <c:pt idx="14">
                  <c:v>92.425150000000002</c:v>
                </c:pt>
                <c:pt idx="15">
                  <c:v>93.664270000000002</c:v>
                </c:pt>
                <c:pt idx="16">
                  <c:v>93.605639999999994</c:v>
                </c:pt>
                <c:pt idx="17">
                  <c:v>95.628450000000001</c:v>
                </c:pt>
                <c:pt idx="18">
                  <c:v>94.105530000000002</c:v>
                </c:pt>
                <c:pt idx="19">
                  <c:v>92.76173</c:v>
                </c:pt>
                <c:pt idx="20">
                  <c:v>93.6703200000000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986-AE47-8D38-E114376F9109}"/>
            </c:ext>
          </c:extLst>
        </c:ser>
        <c:ser>
          <c:idx val="1"/>
          <c:order val="1"/>
          <c:tx>
            <c:strRef>
              <c:f>Foglio2!$C$4</c:f>
              <c:strCache>
                <c:ptCount val="1"/>
                <c:pt idx="0">
                  <c:v>% heterozygous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Foglio2!$A$5:$A$25</c:f>
              <c:strCache>
                <c:ptCount val="21"/>
                <c:pt idx="0">
                  <c:v>1A</c:v>
                </c:pt>
                <c:pt idx="1">
                  <c:v>2A</c:v>
                </c:pt>
                <c:pt idx="2">
                  <c:v>3A</c:v>
                </c:pt>
                <c:pt idx="3">
                  <c:v>4A</c:v>
                </c:pt>
                <c:pt idx="4">
                  <c:v>5A</c:v>
                </c:pt>
                <c:pt idx="5">
                  <c:v>6A</c:v>
                </c:pt>
                <c:pt idx="6">
                  <c:v>7A</c:v>
                </c:pt>
                <c:pt idx="7">
                  <c:v>1B</c:v>
                </c:pt>
                <c:pt idx="8">
                  <c:v>2B</c:v>
                </c:pt>
                <c:pt idx="9">
                  <c:v>3B</c:v>
                </c:pt>
                <c:pt idx="10">
                  <c:v>4B</c:v>
                </c:pt>
                <c:pt idx="11">
                  <c:v>5B</c:v>
                </c:pt>
                <c:pt idx="12">
                  <c:v>6B</c:v>
                </c:pt>
                <c:pt idx="13">
                  <c:v>7B</c:v>
                </c:pt>
                <c:pt idx="14">
                  <c:v>1D</c:v>
                </c:pt>
                <c:pt idx="15">
                  <c:v>2D</c:v>
                </c:pt>
                <c:pt idx="16">
                  <c:v>3D</c:v>
                </c:pt>
                <c:pt idx="17">
                  <c:v>4D</c:v>
                </c:pt>
                <c:pt idx="18">
                  <c:v>5D</c:v>
                </c:pt>
                <c:pt idx="19">
                  <c:v>6D</c:v>
                </c:pt>
                <c:pt idx="20">
                  <c:v>7D</c:v>
                </c:pt>
              </c:strCache>
            </c:strRef>
          </c:cat>
          <c:val>
            <c:numRef>
              <c:f>Foglio2!$C$5:$C$25</c:f>
              <c:numCache>
                <c:formatCode>0.00</c:formatCode>
                <c:ptCount val="21"/>
                <c:pt idx="0">
                  <c:v>6.7659500000000001</c:v>
                </c:pt>
                <c:pt idx="1">
                  <c:v>7.3042600000000002</c:v>
                </c:pt>
                <c:pt idx="2">
                  <c:v>5.3251299999999997</c:v>
                </c:pt>
                <c:pt idx="3">
                  <c:v>5.3997900000000003</c:v>
                </c:pt>
                <c:pt idx="4">
                  <c:v>4.8297999999999996</c:v>
                </c:pt>
                <c:pt idx="5">
                  <c:v>5.6583600000000001</c:v>
                </c:pt>
                <c:pt idx="6">
                  <c:v>5.3323599999999995</c:v>
                </c:pt>
                <c:pt idx="7">
                  <c:v>5.4421400000000002</c:v>
                </c:pt>
                <c:pt idx="8">
                  <c:v>6.7004499999999991</c:v>
                </c:pt>
                <c:pt idx="9">
                  <c:v>5.2404700000000002</c:v>
                </c:pt>
                <c:pt idx="10">
                  <c:v>4.5845099999999999</c:v>
                </c:pt>
                <c:pt idx="11">
                  <c:v>5.0001700000000007</c:v>
                </c:pt>
                <c:pt idx="12">
                  <c:v>6.14717</c:v>
                </c:pt>
                <c:pt idx="13">
                  <c:v>4.9766400000000006</c:v>
                </c:pt>
                <c:pt idx="14">
                  <c:v>7.5748499999999996</c:v>
                </c:pt>
                <c:pt idx="15">
                  <c:v>6.3357300000000008</c:v>
                </c:pt>
                <c:pt idx="16">
                  <c:v>6.3943600000000007</c:v>
                </c:pt>
                <c:pt idx="17">
                  <c:v>4.37155</c:v>
                </c:pt>
                <c:pt idx="18">
                  <c:v>5.8944700000000001</c:v>
                </c:pt>
                <c:pt idx="19">
                  <c:v>7.2382699999999991</c:v>
                </c:pt>
                <c:pt idx="20">
                  <c:v>6.32967999999999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986-AE47-8D38-E114376F910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6"/>
        <c:overlap val="100"/>
        <c:axId val="1123517695"/>
        <c:axId val="1123202655"/>
      </c:barChart>
      <c:catAx>
        <c:axId val="112351769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it-IT"/>
          </a:p>
        </c:txPr>
        <c:crossAx val="1123202655"/>
        <c:crosses val="autoZero"/>
        <c:auto val="1"/>
        <c:lblAlgn val="ctr"/>
        <c:lblOffset val="100"/>
        <c:noMultiLvlLbl val="0"/>
      </c:catAx>
      <c:valAx>
        <c:axId val="1123202655"/>
        <c:scaling>
          <c:orientation val="minMax"/>
          <c:max val="100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it-IT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ercentage</a:t>
                </a:r>
                <a:endParaRPr lang="it-IT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it-IT"/>
            </a:p>
          </c:txPr>
        </c:title>
        <c:numFmt formatCode="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it-IT"/>
          </a:p>
        </c:txPr>
        <c:crossAx val="1123517695"/>
        <c:crosses val="autoZero"/>
        <c:crossBetween val="between"/>
        <c:majorUnit val="20"/>
        <c:minorUnit val="1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it-IT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it-IT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5015245-5D38-3F63-1094-9BD61D64F7B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502CF47A-34FC-0602-37F7-17CFC243039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D2103C2A-D18E-1FE1-4756-993D58A351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E23496-DF1B-FA48-BCDE-0955DDC725CC}" type="datetimeFigureOut">
              <a:rPr lang="it-IT" smtClean="0"/>
              <a:t>04/11/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BFD110DE-AB67-A293-E217-905C02F847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70858CDB-0A08-8DAC-3DF2-435891240B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EC6616-103E-484E-B3F7-09B518FFBD1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834093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7C2C3AC-9E10-1C38-3307-191D9363084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383F597C-F86E-ECE0-7A12-C3945BC87CD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4353D914-A4DA-1C2B-10CF-36181FDC5C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E23496-DF1B-FA48-BCDE-0955DDC725CC}" type="datetimeFigureOut">
              <a:rPr lang="it-IT" smtClean="0"/>
              <a:t>04/11/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E7A14959-B1A2-D2E6-A0DF-638CBB97E2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17DC9222-12ED-BE3A-36DC-69519E0A73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EC6616-103E-484E-B3F7-09B518FFBD1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091577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6870A21B-3CFE-6E91-B173-A3B282B1B9E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4F6C25E5-AD53-02AA-13E5-5B131C2C94B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3E24BF44-85CE-BEBA-3B34-C7D19C6854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E23496-DF1B-FA48-BCDE-0955DDC725CC}" type="datetimeFigureOut">
              <a:rPr lang="it-IT" smtClean="0"/>
              <a:t>04/11/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4270E91D-6717-1D00-43FF-6EC6E998F8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7F6DB6E1-23B4-2AFC-5F8F-4F5E0F620D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EC6616-103E-484E-B3F7-09B518FFBD1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017437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DD84132-623F-4868-B9AB-F6BD57E326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7D7389CF-1FA0-22B0-94E7-33EA90E9B7E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8EFD3C87-351E-9B19-37F5-7FCD6E96DE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E23496-DF1B-FA48-BCDE-0955DDC725CC}" type="datetimeFigureOut">
              <a:rPr lang="it-IT" smtClean="0"/>
              <a:t>04/11/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BF3CAADC-0B7C-EF91-A4E7-DD534E0F70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5CCF179B-577C-5709-D5F0-B706DC2998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EC6616-103E-484E-B3F7-09B518FFBD1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210798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633DE066-963A-C369-E7F9-BB07354CB8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68CF400D-3936-32E0-F15D-A096BFAFC1C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BE1F1994-07BA-0A25-BCE0-2641575202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E23496-DF1B-FA48-BCDE-0955DDC725CC}" type="datetimeFigureOut">
              <a:rPr lang="it-IT" smtClean="0"/>
              <a:t>04/11/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9A50C4D4-AE39-CF21-2BE5-915B6F74BE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F791B026-B638-FF6C-DEAF-5958C2F0F1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EC6616-103E-484E-B3F7-09B518FFBD1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39640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B4AF0AD-9812-A181-CA34-201AE504F66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491F2A48-F26B-49B6-B75E-1D4318395E8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A7FD0BC3-5BC8-991C-7723-79A7DC51A7E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A21234C1-540E-AD0F-4C59-7BAF8895A7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E23496-DF1B-FA48-BCDE-0955DDC725CC}" type="datetimeFigureOut">
              <a:rPr lang="it-IT" smtClean="0"/>
              <a:t>04/11/22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FF91C2CB-9EFB-B78B-FBD7-26F3142DB1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E0048BD6-50AD-D75D-CD4F-586BBFC3D0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EC6616-103E-484E-B3F7-09B518FFBD1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730904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AAE9F72-713E-3334-C13D-0CDA1FE2B1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6E78C820-2C4E-3483-BC61-9133BB5F280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88E53E44-C71D-004D-690D-E0762A72800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42785229-37F1-F89E-2CEA-556E1515FC3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B2CFEE67-66DC-D84C-0887-D0F5F7941F2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77C46548-8430-B7C9-52AE-51F8098450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E23496-DF1B-FA48-BCDE-0955DDC725CC}" type="datetimeFigureOut">
              <a:rPr lang="it-IT" smtClean="0"/>
              <a:t>04/11/22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A0549912-C859-09B4-1E59-86089A414D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2512F521-8C2D-F577-C561-E265CCF94C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EC6616-103E-484E-B3F7-09B518FFBD1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554015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5895D7B-C3C5-7E09-E390-EA54691E72D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14B060D4-87CF-A4E3-9FF0-8BEFA1F045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E23496-DF1B-FA48-BCDE-0955DDC725CC}" type="datetimeFigureOut">
              <a:rPr lang="it-IT" smtClean="0"/>
              <a:t>04/11/22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88A3E06A-2018-3865-0F99-B2FA69395B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E95ECE54-610E-1FB7-4077-20B1D3F74E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EC6616-103E-484E-B3F7-09B518FFBD1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603487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8D7D1680-9843-DF02-52EA-D4030CCA85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E23496-DF1B-FA48-BCDE-0955DDC725CC}" type="datetimeFigureOut">
              <a:rPr lang="it-IT" smtClean="0"/>
              <a:t>04/11/22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E0CF480D-A5EC-3FBA-7B67-D5E68B03DD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B9AF0530-2724-EDB5-835D-75D90BC6C2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EC6616-103E-484E-B3F7-09B518FFBD1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737472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E6DB774-ADB2-7F0E-A793-02F08AEE8A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B8FA9DCB-61CA-0819-ED96-F84732AB9F5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6E23F629-3EBB-570A-B9C1-1AF05DE0710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E9E332E9-655B-0149-F63C-C5B1F35798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E23496-DF1B-FA48-BCDE-0955DDC725CC}" type="datetimeFigureOut">
              <a:rPr lang="it-IT" smtClean="0"/>
              <a:t>04/11/22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5D6EFCA6-6B37-8B67-3107-08EF8E4E24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E1DDCC28-F66A-9E8C-25DA-C0A3572676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EC6616-103E-484E-B3F7-09B518FFBD1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123187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372D3E0-39F0-B921-6208-5EF6E09546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64A982C7-3251-DB86-FCC0-94E32B95946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0A819491-5E6D-3188-4371-654A984FC89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DC3DD65C-598E-0C6C-87BB-61217E78BC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E23496-DF1B-FA48-BCDE-0955DDC725CC}" type="datetimeFigureOut">
              <a:rPr lang="it-IT" smtClean="0"/>
              <a:t>04/11/22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1CDEE101-A881-6577-61DC-6D43EA3AE5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698B0592-E890-7F06-FE48-3758A19223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EC6616-103E-484E-B3F7-09B518FFBD1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808825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3C8696EE-3DA6-59EB-4021-9D7BBFAF3C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C75E43EA-025C-DF45-0E6C-9593DD61567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F36C06E5-FE83-6DD0-DE41-A81D4C6F971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E23496-DF1B-FA48-BCDE-0955DDC725CC}" type="datetimeFigureOut">
              <a:rPr lang="it-IT" smtClean="0"/>
              <a:t>04/11/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9BA8CBCA-19EF-1D3D-1A0F-A7F3F93D498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5AF5FCCD-89CB-1033-E594-220AA5A192E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EC6616-103E-484E-B3F7-09B518FFBD1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561211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Grafico 3">
            <a:extLst>
              <a:ext uri="{FF2B5EF4-FFF2-40B4-BE49-F238E27FC236}">
                <a16:creationId xmlns:a16="http://schemas.microsoft.com/office/drawing/2014/main" id="{960AE27E-A273-405F-A09E-2B1ED06B769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05626240"/>
              </p:ext>
            </p:extLst>
          </p:nvPr>
        </p:nvGraphicFramePr>
        <p:xfrm>
          <a:off x="662609" y="556593"/>
          <a:ext cx="11065565" cy="581770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CasellaDiTesto 2">
            <a:extLst>
              <a:ext uri="{FF2B5EF4-FFF2-40B4-BE49-F238E27FC236}">
                <a16:creationId xmlns:a16="http://schemas.microsoft.com/office/drawing/2014/main" id="{E09F4749-5934-62C6-C67D-85B2D9641CAC}"/>
              </a:ext>
            </a:extLst>
          </p:cNvPr>
          <p:cNvSpPr txBox="1"/>
          <p:nvPr/>
        </p:nvSpPr>
        <p:spPr>
          <a:xfrm>
            <a:off x="-10161" y="6374342"/>
            <a:ext cx="12096143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spcBef>
                <a:spcPts val="600"/>
              </a:spcBef>
              <a:spcAft>
                <a:spcPts val="1200"/>
              </a:spcAft>
            </a:pP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S2. 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tacked bar chart showing the level of heterozygosity retention in the F6:F7 RIL population. Blue bars are for homozygous alleles; orange bars are for heterozygous alleles. Chromosomes are shown on the x-axis.</a:t>
            </a:r>
            <a:endParaRPr lang="it-IT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5154156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43</Words>
  <Application>Microsoft Macintosh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Salvatore Esposito</dc:creator>
  <cp:lastModifiedBy>Salvatore Esposito</cp:lastModifiedBy>
  <cp:revision>3</cp:revision>
  <dcterms:created xsi:type="dcterms:W3CDTF">2022-07-13T12:59:03Z</dcterms:created>
  <dcterms:modified xsi:type="dcterms:W3CDTF">2022-11-04T13:43:31Z</dcterms:modified>
</cp:coreProperties>
</file>